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7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588" autoAdjust="0"/>
    <p:restoredTop sz="93525" autoAdjust="0"/>
  </p:normalViewPr>
  <p:slideViewPr>
    <p:cSldViewPr>
      <p:cViewPr>
        <p:scale>
          <a:sx n="66" d="100"/>
          <a:sy n="66" d="100"/>
        </p:scale>
        <p:origin x="-1506" y="-14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75A8E-13A5-4CBB-9016-DEB086C42D2B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DB579E-D501-4566-8FAA-EF4A07072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385253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236687-0CE9-4136-8A0B-633186271BDA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746125"/>
            <a:ext cx="49657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5125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C9530C-0838-4A3F-9753-757BFD245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9564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7347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11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6718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221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19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0718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0643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8642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591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1208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946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175A3-6C5A-4B6E-9BE4-499513501A4C}" type="datetimeFigureOut">
              <a:rPr kumimoji="1" lang="ja-JP" altLang="en-US" smtClean="0"/>
              <a:t>2015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902F0-FD16-4CCA-BD32-731DEC8040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3547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6"/>
          <p:cNvPicPr preferRelativeResize="0"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-18000" contrast="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289" r="12673"/>
          <a:stretch/>
        </p:blipFill>
        <p:spPr bwMode="auto">
          <a:xfrm flipH="1">
            <a:off x="3634962" y="981543"/>
            <a:ext cx="2395541" cy="513480"/>
          </a:xfrm>
          <a:prstGeom prst="rect">
            <a:avLst/>
          </a:prstGeom>
          <a:ln w="9525">
            <a:solidFill>
              <a:schemeClr val="tx1"/>
            </a:solidFill>
            <a:miter lim="800000"/>
            <a:headEnd/>
            <a:tailEnd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" name="Picture 2" descr="C:\Users\Hashimoto.Ayako\Desktop\PLOS ONE\Akt.ti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3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824" t="47531" r="31129" b="40976"/>
          <a:stretch/>
        </p:blipFill>
        <p:spPr bwMode="auto">
          <a:xfrm flipH="1">
            <a:off x="3634963" y="1569682"/>
            <a:ext cx="2395542" cy="516459"/>
          </a:xfrm>
          <a:prstGeom prst="rect">
            <a:avLst/>
          </a:prstGeom>
          <a:ln w="190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4503664" y="2768320"/>
            <a:ext cx="196657" cy="323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*</a:t>
            </a:r>
            <a:endParaRPr kumimoji="1"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832735" y="3018145"/>
            <a:ext cx="196657" cy="323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*</a:t>
            </a:r>
            <a:endParaRPr kumimoji="1" lang="ja-JP" altLang="en-US" dirty="0"/>
          </a:p>
        </p:txBody>
      </p:sp>
      <p:sp>
        <p:nvSpPr>
          <p:cNvPr id="6" name="Text Box 135"/>
          <p:cNvSpPr txBox="1">
            <a:spLocks noChangeArrowheads="1"/>
          </p:cNvSpPr>
          <p:nvPr/>
        </p:nvSpPr>
        <p:spPr bwMode="auto">
          <a:xfrm>
            <a:off x="3635263" y="296682"/>
            <a:ext cx="2395241" cy="5693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dirty="0" smtClean="0">
                <a:latin typeface="Times New Roman" pitchFamily="18" charset="0"/>
              </a:rPr>
              <a:t>           </a:t>
            </a:r>
            <a:r>
              <a:rPr lang="en-US" altLang="ja-JP" sz="1200" dirty="0" err="1" smtClean="0">
                <a:latin typeface="Times New Roman" pitchFamily="18" charset="0"/>
              </a:rPr>
              <a:t>Veh</a:t>
            </a:r>
            <a:r>
              <a:rPr lang="en-US" altLang="ja-JP" sz="1200" dirty="0" smtClean="0">
                <a:latin typeface="Times New Roman" pitchFamily="18" charset="0"/>
              </a:rPr>
              <a:t>                 CL30</a:t>
            </a:r>
          </a:p>
          <a:p>
            <a:pPr eaLnBrk="1" hangingPunct="1">
              <a:spcBef>
                <a:spcPct val="0"/>
              </a:spcBef>
              <a:buNone/>
            </a:pPr>
            <a:endParaRPr lang="en-US" altLang="ja-JP" sz="700" dirty="0" smtClean="0">
              <a:latin typeface="Times New Roman" pitchFamily="18" charset="0"/>
            </a:endParaRP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200" dirty="0">
                <a:latin typeface="Times New Roman" pitchFamily="18" charset="0"/>
              </a:rPr>
              <a:t> </a:t>
            </a:r>
            <a:r>
              <a:rPr lang="en-US" altLang="ja-JP" sz="1200" dirty="0" err="1">
                <a:latin typeface="Times New Roman" pitchFamily="18" charset="0"/>
              </a:rPr>
              <a:t>iCt</a:t>
            </a:r>
            <a:r>
              <a:rPr lang="en-US" altLang="ja-JP" sz="1200" dirty="0">
                <a:latin typeface="Times New Roman" pitchFamily="18" charset="0"/>
              </a:rPr>
              <a:t> </a:t>
            </a:r>
            <a:r>
              <a:rPr lang="en-US" altLang="ja-JP" sz="1200" dirty="0" smtClean="0">
                <a:latin typeface="Times New Roman" pitchFamily="18" charset="0"/>
              </a:rPr>
              <a:t>    iEpac-1          </a:t>
            </a:r>
            <a:r>
              <a:rPr lang="en-US" altLang="ja-JP" sz="1200" dirty="0" err="1" smtClean="0">
                <a:latin typeface="Times New Roman" pitchFamily="18" charset="0"/>
              </a:rPr>
              <a:t>iCt</a:t>
            </a:r>
            <a:r>
              <a:rPr lang="en-US" altLang="ja-JP" sz="1200" dirty="0" smtClean="0">
                <a:latin typeface="Times New Roman" pitchFamily="18" charset="0"/>
              </a:rPr>
              <a:t>     iEpac-1 </a:t>
            </a:r>
            <a:endParaRPr lang="en-US" altLang="ja-JP" sz="1200" dirty="0">
              <a:latin typeface="Times New Roman" pitchFamily="18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 rot="16200000">
            <a:off x="2224080" y="4372353"/>
            <a:ext cx="208399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Total protein*100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線コネクタ 7"/>
          <p:cNvCxnSpPr/>
          <p:nvPr/>
        </p:nvCxnSpPr>
        <p:spPr>
          <a:xfrm>
            <a:off x="3722371" y="592987"/>
            <a:ext cx="9584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 Box 122"/>
          <p:cNvSpPr txBox="1">
            <a:spLocks noChangeArrowheads="1"/>
          </p:cNvSpPr>
          <p:nvPr/>
        </p:nvSpPr>
        <p:spPr bwMode="auto">
          <a:xfrm>
            <a:off x="2809779" y="1106489"/>
            <a:ext cx="912592" cy="277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Times New Roman" pitchFamily="18" charset="0"/>
                <a:cs typeface="Times New Roman" pitchFamily="18" charset="0"/>
              </a:rPr>
              <a:t>P-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MAPK</a:t>
            </a:r>
            <a:endParaRPr lang="en-US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 Box 173"/>
          <p:cNvSpPr txBox="1">
            <a:spLocks noChangeArrowheads="1"/>
          </p:cNvSpPr>
          <p:nvPr/>
        </p:nvSpPr>
        <p:spPr bwMode="auto">
          <a:xfrm>
            <a:off x="2925213" y="1639867"/>
            <a:ext cx="709750" cy="277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defRPr/>
            </a:pPr>
            <a:r>
              <a:rPr lang="en-US" altLang="ja-JP" sz="1200" dirty="0" smtClean="0">
                <a:latin typeface="Times New Roman" pitchFamily="18" charset="0"/>
              </a:rPr>
              <a:t>P-</a:t>
            </a:r>
            <a:r>
              <a:rPr lang="en-US" altLang="ja-JP" sz="1200" dirty="0" err="1" smtClean="0">
                <a:latin typeface="Times New Roman" pitchFamily="18" charset="0"/>
              </a:rPr>
              <a:t>Akt</a:t>
            </a:r>
            <a:endParaRPr lang="en-US" altLang="ja-JP" sz="1200" dirty="0" smtClean="0">
              <a:latin typeface="Times New Roman" pitchFamily="18" charset="0"/>
            </a:endParaRPr>
          </a:p>
        </p:txBody>
      </p:sp>
      <p:sp>
        <p:nvSpPr>
          <p:cNvPr id="11" name="Rectangle 74"/>
          <p:cNvSpPr>
            <a:spLocks noChangeArrowheads="1"/>
          </p:cNvSpPr>
          <p:nvPr/>
        </p:nvSpPr>
        <p:spPr bwMode="auto">
          <a:xfrm>
            <a:off x="3722371" y="6023079"/>
            <a:ext cx="2134145" cy="2280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 err="1">
                <a:solidFill>
                  <a:srgbClr val="000000"/>
                </a:solidFill>
                <a:latin typeface="Times New Roman" pitchFamily="18" charset="0"/>
              </a:rPr>
              <a:t>Cilostazol</a:t>
            </a:r>
            <a:r>
              <a:rPr lang="en-US" altLang="ja-JP" sz="1200" dirty="0">
                <a:solidFill>
                  <a:srgbClr val="000000"/>
                </a:solidFill>
                <a:latin typeface="Times New Roman" pitchFamily="18" charset="0"/>
              </a:rPr>
              <a:t> (30 </a:t>
            </a:r>
            <a:r>
              <a:rPr lang="en-US" altLang="ja-JP" sz="12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µM) </a:t>
            </a:r>
            <a:endParaRPr lang="en-US" altLang="ja-JP" sz="1200" dirty="0">
              <a:solidFill>
                <a:srgbClr val="000000"/>
              </a:solidFill>
              <a:latin typeface="Times New Roman" pitchFamily="18" charset="0"/>
            </a:endParaRPr>
          </a:p>
        </p:txBody>
      </p:sp>
      <p:sp>
        <p:nvSpPr>
          <p:cNvPr id="12" name="Line 136"/>
          <p:cNvSpPr>
            <a:spLocks noChangeShapeType="1"/>
          </p:cNvSpPr>
          <p:nvPr/>
        </p:nvSpPr>
        <p:spPr bwMode="auto">
          <a:xfrm>
            <a:off x="4019416" y="5952980"/>
            <a:ext cx="1652549" cy="0"/>
          </a:xfrm>
          <a:prstGeom prst="line">
            <a:avLst/>
          </a:prstGeom>
          <a:ln>
            <a:solidFill>
              <a:schemeClr val="tx1"/>
            </a:solidFill>
            <a:headEnd/>
            <a:tailEnd/>
          </a:ln>
          <a:extLst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>
              <a:cs typeface="ＭＳ Ｐゴシック" charset="0"/>
            </a:endParaRPr>
          </a:p>
        </p:txBody>
      </p:sp>
      <p:cxnSp>
        <p:nvCxnSpPr>
          <p:cNvPr id="13" name="直線コネクタ 12"/>
          <p:cNvCxnSpPr/>
          <p:nvPr/>
        </p:nvCxnSpPr>
        <p:spPr>
          <a:xfrm>
            <a:off x="4864490" y="589815"/>
            <a:ext cx="9584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AutoShape 130"/>
          <p:cNvSpPr>
            <a:spLocks/>
          </p:cNvSpPr>
          <p:nvPr/>
        </p:nvSpPr>
        <p:spPr bwMode="auto">
          <a:xfrm rot="5400000">
            <a:off x="4531421" y="2642788"/>
            <a:ext cx="225087" cy="1091689"/>
          </a:xfrm>
          <a:prstGeom prst="leftBracket">
            <a:avLst>
              <a:gd name="adj" fmla="val 0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200"/>
          </a:p>
        </p:txBody>
      </p:sp>
      <p:sp>
        <p:nvSpPr>
          <p:cNvPr id="16" name="AutoShape 130"/>
          <p:cNvSpPr>
            <a:spLocks/>
          </p:cNvSpPr>
          <p:nvPr/>
        </p:nvSpPr>
        <p:spPr bwMode="auto">
          <a:xfrm rot="5400000">
            <a:off x="4916848" y="2898570"/>
            <a:ext cx="225087" cy="1091689"/>
          </a:xfrm>
          <a:prstGeom prst="leftBracket">
            <a:avLst>
              <a:gd name="adj" fmla="val 0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200"/>
          </a:p>
        </p:txBody>
      </p:sp>
      <p:sp>
        <p:nvSpPr>
          <p:cNvPr id="17" name="AutoShape 4"/>
          <p:cNvSpPr>
            <a:spLocks noChangeAspect="1" noChangeArrowheads="1" noTextEdit="1"/>
          </p:cNvSpPr>
          <p:nvPr/>
        </p:nvSpPr>
        <p:spPr bwMode="auto">
          <a:xfrm>
            <a:off x="3108443" y="2389187"/>
            <a:ext cx="2908300" cy="4075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Freeform 6"/>
          <p:cNvSpPr>
            <a:spLocks noEditPoints="1"/>
          </p:cNvSpPr>
          <p:nvPr/>
        </p:nvSpPr>
        <p:spPr bwMode="auto">
          <a:xfrm>
            <a:off x="3975218" y="3692525"/>
            <a:ext cx="1403350" cy="1939925"/>
          </a:xfrm>
          <a:custGeom>
            <a:avLst/>
            <a:gdLst>
              <a:gd name="T0" fmla="*/ 0 w 1766"/>
              <a:gd name="T1" fmla="*/ 0 h 2444"/>
              <a:gd name="T2" fmla="*/ 393 w 1766"/>
              <a:gd name="T3" fmla="*/ 0 h 2444"/>
              <a:gd name="T4" fmla="*/ 393 w 1766"/>
              <a:gd name="T5" fmla="*/ 2444 h 2444"/>
              <a:gd name="T6" fmla="*/ 0 w 1766"/>
              <a:gd name="T7" fmla="*/ 2444 h 2444"/>
              <a:gd name="T8" fmla="*/ 0 w 1766"/>
              <a:gd name="T9" fmla="*/ 0 h 2444"/>
              <a:gd name="T10" fmla="*/ 1375 w 1766"/>
              <a:gd name="T11" fmla="*/ 867 h 2444"/>
              <a:gd name="T12" fmla="*/ 1766 w 1766"/>
              <a:gd name="T13" fmla="*/ 867 h 2444"/>
              <a:gd name="T14" fmla="*/ 1766 w 1766"/>
              <a:gd name="T15" fmla="*/ 2444 h 2444"/>
              <a:gd name="T16" fmla="*/ 1375 w 1766"/>
              <a:gd name="T17" fmla="*/ 2444 h 2444"/>
              <a:gd name="T18" fmla="*/ 1375 w 1766"/>
              <a:gd name="T19" fmla="*/ 867 h 24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766" h="2444">
                <a:moveTo>
                  <a:pt x="0" y="0"/>
                </a:moveTo>
                <a:lnTo>
                  <a:pt x="393" y="0"/>
                </a:lnTo>
                <a:lnTo>
                  <a:pt x="393" y="2444"/>
                </a:lnTo>
                <a:lnTo>
                  <a:pt x="0" y="2444"/>
                </a:lnTo>
                <a:lnTo>
                  <a:pt x="0" y="0"/>
                </a:lnTo>
                <a:close/>
                <a:moveTo>
                  <a:pt x="1375" y="867"/>
                </a:moveTo>
                <a:lnTo>
                  <a:pt x="1766" y="867"/>
                </a:lnTo>
                <a:lnTo>
                  <a:pt x="1766" y="2444"/>
                </a:lnTo>
                <a:lnTo>
                  <a:pt x="1375" y="2444"/>
                </a:lnTo>
                <a:lnTo>
                  <a:pt x="1375" y="867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" name="Rectangle 7"/>
          <p:cNvSpPr>
            <a:spLocks noChangeArrowheads="1"/>
          </p:cNvSpPr>
          <p:nvPr/>
        </p:nvSpPr>
        <p:spPr bwMode="auto">
          <a:xfrm>
            <a:off x="4287956" y="3832225"/>
            <a:ext cx="311150" cy="18002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" name="Freeform 8"/>
          <p:cNvSpPr>
            <a:spLocks noEditPoints="1"/>
          </p:cNvSpPr>
          <p:nvPr/>
        </p:nvSpPr>
        <p:spPr bwMode="auto">
          <a:xfrm>
            <a:off x="4283193" y="3827462"/>
            <a:ext cx="320675" cy="1809750"/>
          </a:xfrm>
          <a:custGeom>
            <a:avLst/>
            <a:gdLst>
              <a:gd name="T0" fmla="*/ 0 w 403"/>
              <a:gd name="T1" fmla="*/ 6 h 2279"/>
              <a:gd name="T2" fmla="*/ 0 w 403"/>
              <a:gd name="T3" fmla="*/ 0 h 2279"/>
              <a:gd name="T4" fmla="*/ 5 w 403"/>
              <a:gd name="T5" fmla="*/ 0 h 2279"/>
              <a:gd name="T6" fmla="*/ 397 w 403"/>
              <a:gd name="T7" fmla="*/ 0 h 2279"/>
              <a:gd name="T8" fmla="*/ 401 w 403"/>
              <a:gd name="T9" fmla="*/ 0 h 2279"/>
              <a:gd name="T10" fmla="*/ 403 w 403"/>
              <a:gd name="T11" fmla="*/ 6 h 2279"/>
              <a:gd name="T12" fmla="*/ 403 w 403"/>
              <a:gd name="T13" fmla="*/ 2274 h 2279"/>
              <a:gd name="T14" fmla="*/ 401 w 403"/>
              <a:gd name="T15" fmla="*/ 2278 h 2279"/>
              <a:gd name="T16" fmla="*/ 397 w 403"/>
              <a:gd name="T17" fmla="*/ 2279 h 2279"/>
              <a:gd name="T18" fmla="*/ 5 w 403"/>
              <a:gd name="T19" fmla="*/ 2279 h 2279"/>
              <a:gd name="T20" fmla="*/ 0 w 403"/>
              <a:gd name="T21" fmla="*/ 2278 h 2279"/>
              <a:gd name="T22" fmla="*/ 0 w 403"/>
              <a:gd name="T23" fmla="*/ 2274 h 2279"/>
              <a:gd name="T24" fmla="*/ 0 w 403"/>
              <a:gd name="T25" fmla="*/ 6 h 2279"/>
              <a:gd name="T26" fmla="*/ 11 w 403"/>
              <a:gd name="T27" fmla="*/ 2274 h 2279"/>
              <a:gd name="T28" fmla="*/ 5 w 403"/>
              <a:gd name="T29" fmla="*/ 2268 h 2279"/>
              <a:gd name="T30" fmla="*/ 397 w 403"/>
              <a:gd name="T31" fmla="*/ 2268 h 2279"/>
              <a:gd name="T32" fmla="*/ 391 w 403"/>
              <a:gd name="T33" fmla="*/ 2274 h 2279"/>
              <a:gd name="T34" fmla="*/ 391 w 403"/>
              <a:gd name="T35" fmla="*/ 6 h 2279"/>
              <a:gd name="T36" fmla="*/ 397 w 403"/>
              <a:gd name="T37" fmla="*/ 12 h 2279"/>
              <a:gd name="T38" fmla="*/ 5 w 403"/>
              <a:gd name="T39" fmla="*/ 12 h 2279"/>
              <a:gd name="T40" fmla="*/ 11 w 403"/>
              <a:gd name="T41" fmla="*/ 6 h 2279"/>
              <a:gd name="T42" fmla="*/ 11 w 403"/>
              <a:gd name="T43" fmla="*/ 2274 h 22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403" h="2279">
                <a:moveTo>
                  <a:pt x="0" y="6"/>
                </a:moveTo>
                <a:lnTo>
                  <a:pt x="0" y="0"/>
                </a:lnTo>
                <a:lnTo>
                  <a:pt x="5" y="0"/>
                </a:lnTo>
                <a:lnTo>
                  <a:pt x="397" y="0"/>
                </a:lnTo>
                <a:lnTo>
                  <a:pt x="401" y="0"/>
                </a:lnTo>
                <a:lnTo>
                  <a:pt x="403" y="6"/>
                </a:lnTo>
                <a:lnTo>
                  <a:pt x="403" y="2274"/>
                </a:lnTo>
                <a:lnTo>
                  <a:pt x="401" y="2278"/>
                </a:lnTo>
                <a:lnTo>
                  <a:pt x="397" y="2279"/>
                </a:lnTo>
                <a:lnTo>
                  <a:pt x="5" y="2279"/>
                </a:lnTo>
                <a:lnTo>
                  <a:pt x="0" y="2278"/>
                </a:lnTo>
                <a:lnTo>
                  <a:pt x="0" y="2274"/>
                </a:lnTo>
                <a:lnTo>
                  <a:pt x="0" y="6"/>
                </a:lnTo>
                <a:close/>
                <a:moveTo>
                  <a:pt x="11" y="2274"/>
                </a:moveTo>
                <a:lnTo>
                  <a:pt x="5" y="2268"/>
                </a:lnTo>
                <a:lnTo>
                  <a:pt x="397" y="2268"/>
                </a:lnTo>
                <a:lnTo>
                  <a:pt x="391" y="2274"/>
                </a:lnTo>
                <a:lnTo>
                  <a:pt x="391" y="6"/>
                </a:lnTo>
                <a:lnTo>
                  <a:pt x="397" y="12"/>
                </a:lnTo>
                <a:lnTo>
                  <a:pt x="5" y="12"/>
                </a:lnTo>
                <a:lnTo>
                  <a:pt x="11" y="6"/>
                </a:lnTo>
                <a:lnTo>
                  <a:pt x="11" y="2274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" name="Rectangle 9"/>
          <p:cNvSpPr>
            <a:spLocks noChangeArrowheads="1"/>
          </p:cNvSpPr>
          <p:nvPr/>
        </p:nvSpPr>
        <p:spPr bwMode="auto">
          <a:xfrm>
            <a:off x="5378568" y="4032250"/>
            <a:ext cx="312738" cy="16002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" name="Freeform 10"/>
          <p:cNvSpPr>
            <a:spLocks noEditPoints="1"/>
          </p:cNvSpPr>
          <p:nvPr/>
        </p:nvSpPr>
        <p:spPr bwMode="auto">
          <a:xfrm>
            <a:off x="5373806" y="4027487"/>
            <a:ext cx="320675" cy="1609725"/>
          </a:xfrm>
          <a:custGeom>
            <a:avLst/>
            <a:gdLst>
              <a:gd name="T0" fmla="*/ 0 w 405"/>
              <a:gd name="T1" fmla="*/ 6 h 2027"/>
              <a:gd name="T2" fmla="*/ 0 w 405"/>
              <a:gd name="T3" fmla="*/ 0 h 2027"/>
              <a:gd name="T4" fmla="*/ 5 w 405"/>
              <a:gd name="T5" fmla="*/ 0 h 2027"/>
              <a:gd name="T6" fmla="*/ 399 w 405"/>
              <a:gd name="T7" fmla="*/ 0 h 2027"/>
              <a:gd name="T8" fmla="*/ 403 w 405"/>
              <a:gd name="T9" fmla="*/ 0 h 2027"/>
              <a:gd name="T10" fmla="*/ 405 w 405"/>
              <a:gd name="T11" fmla="*/ 6 h 2027"/>
              <a:gd name="T12" fmla="*/ 405 w 405"/>
              <a:gd name="T13" fmla="*/ 2022 h 2027"/>
              <a:gd name="T14" fmla="*/ 403 w 405"/>
              <a:gd name="T15" fmla="*/ 2026 h 2027"/>
              <a:gd name="T16" fmla="*/ 399 w 405"/>
              <a:gd name="T17" fmla="*/ 2027 h 2027"/>
              <a:gd name="T18" fmla="*/ 5 w 405"/>
              <a:gd name="T19" fmla="*/ 2027 h 2027"/>
              <a:gd name="T20" fmla="*/ 0 w 405"/>
              <a:gd name="T21" fmla="*/ 2026 h 2027"/>
              <a:gd name="T22" fmla="*/ 0 w 405"/>
              <a:gd name="T23" fmla="*/ 2022 h 2027"/>
              <a:gd name="T24" fmla="*/ 0 w 405"/>
              <a:gd name="T25" fmla="*/ 6 h 2027"/>
              <a:gd name="T26" fmla="*/ 11 w 405"/>
              <a:gd name="T27" fmla="*/ 2022 h 2027"/>
              <a:gd name="T28" fmla="*/ 5 w 405"/>
              <a:gd name="T29" fmla="*/ 2016 h 2027"/>
              <a:gd name="T30" fmla="*/ 399 w 405"/>
              <a:gd name="T31" fmla="*/ 2016 h 2027"/>
              <a:gd name="T32" fmla="*/ 393 w 405"/>
              <a:gd name="T33" fmla="*/ 2022 h 2027"/>
              <a:gd name="T34" fmla="*/ 393 w 405"/>
              <a:gd name="T35" fmla="*/ 6 h 2027"/>
              <a:gd name="T36" fmla="*/ 399 w 405"/>
              <a:gd name="T37" fmla="*/ 11 h 2027"/>
              <a:gd name="T38" fmla="*/ 5 w 405"/>
              <a:gd name="T39" fmla="*/ 11 h 2027"/>
              <a:gd name="T40" fmla="*/ 11 w 405"/>
              <a:gd name="T41" fmla="*/ 6 h 2027"/>
              <a:gd name="T42" fmla="*/ 11 w 405"/>
              <a:gd name="T43" fmla="*/ 2022 h 20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405" h="2027">
                <a:moveTo>
                  <a:pt x="0" y="6"/>
                </a:moveTo>
                <a:lnTo>
                  <a:pt x="0" y="0"/>
                </a:lnTo>
                <a:lnTo>
                  <a:pt x="5" y="0"/>
                </a:lnTo>
                <a:lnTo>
                  <a:pt x="399" y="0"/>
                </a:lnTo>
                <a:lnTo>
                  <a:pt x="403" y="0"/>
                </a:lnTo>
                <a:lnTo>
                  <a:pt x="405" y="6"/>
                </a:lnTo>
                <a:lnTo>
                  <a:pt x="405" y="2022"/>
                </a:lnTo>
                <a:lnTo>
                  <a:pt x="403" y="2026"/>
                </a:lnTo>
                <a:lnTo>
                  <a:pt x="399" y="2027"/>
                </a:lnTo>
                <a:lnTo>
                  <a:pt x="5" y="2027"/>
                </a:lnTo>
                <a:lnTo>
                  <a:pt x="0" y="2026"/>
                </a:lnTo>
                <a:lnTo>
                  <a:pt x="0" y="2022"/>
                </a:lnTo>
                <a:lnTo>
                  <a:pt x="0" y="6"/>
                </a:lnTo>
                <a:close/>
                <a:moveTo>
                  <a:pt x="11" y="2022"/>
                </a:moveTo>
                <a:lnTo>
                  <a:pt x="5" y="2016"/>
                </a:lnTo>
                <a:lnTo>
                  <a:pt x="399" y="2016"/>
                </a:lnTo>
                <a:lnTo>
                  <a:pt x="393" y="2022"/>
                </a:lnTo>
                <a:lnTo>
                  <a:pt x="393" y="6"/>
                </a:lnTo>
                <a:lnTo>
                  <a:pt x="399" y="11"/>
                </a:lnTo>
                <a:lnTo>
                  <a:pt x="5" y="11"/>
                </a:lnTo>
                <a:lnTo>
                  <a:pt x="11" y="6"/>
                </a:lnTo>
                <a:lnTo>
                  <a:pt x="11" y="2022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" name="Freeform 11"/>
          <p:cNvSpPr>
            <a:spLocks noEditPoints="1"/>
          </p:cNvSpPr>
          <p:nvPr/>
        </p:nvSpPr>
        <p:spPr bwMode="auto">
          <a:xfrm>
            <a:off x="4103806" y="3616325"/>
            <a:ext cx="57150" cy="76200"/>
          </a:xfrm>
          <a:custGeom>
            <a:avLst/>
            <a:gdLst>
              <a:gd name="T0" fmla="*/ 29 w 71"/>
              <a:gd name="T1" fmla="*/ 96 h 96"/>
              <a:gd name="T2" fmla="*/ 29 w 71"/>
              <a:gd name="T3" fmla="*/ 5 h 96"/>
              <a:gd name="T4" fmla="*/ 40 w 71"/>
              <a:gd name="T5" fmla="*/ 5 h 96"/>
              <a:gd name="T6" fmla="*/ 40 w 71"/>
              <a:gd name="T7" fmla="*/ 96 h 96"/>
              <a:gd name="T8" fmla="*/ 29 w 71"/>
              <a:gd name="T9" fmla="*/ 96 h 96"/>
              <a:gd name="T10" fmla="*/ 0 w 71"/>
              <a:gd name="T11" fmla="*/ 0 h 96"/>
              <a:gd name="T12" fmla="*/ 71 w 71"/>
              <a:gd name="T13" fmla="*/ 0 h 96"/>
              <a:gd name="T14" fmla="*/ 71 w 71"/>
              <a:gd name="T15" fmla="*/ 11 h 96"/>
              <a:gd name="T16" fmla="*/ 0 w 71"/>
              <a:gd name="T17" fmla="*/ 11 h 96"/>
              <a:gd name="T18" fmla="*/ 0 w 71"/>
              <a:gd name="T19" fmla="*/ 0 h 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71" h="96">
                <a:moveTo>
                  <a:pt x="29" y="96"/>
                </a:moveTo>
                <a:lnTo>
                  <a:pt x="29" y="5"/>
                </a:lnTo>
                <a:lnTo>
                  <a:pt x="40" y="5"/>
                </a:lnTo>
                <a:lnTo>
                  <a:pt x="40" y="96"/>
                </a:lnTo>
                <a:lnTo>
                  <a:pt x="29" y="96"/>
                </a:lnTo>
                <a:close/>
                <a:moveTo>
                  <a:pt x="0" y="0"/>
                </a:moveTo>
                <a:lnTo>
                  <a:pt x="71" y="0"/>
                </a:lnTo>
                <a:lnTo>
                  <a:pt x="71" y="11"/>
                </a:lnTo>
                <a:lnTo>
                  <a:pt x="0" y="11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" name="Freeform 12"/>
          <p:cNvSpPr>
            <a:spLocks noEditPoints="1"/>
          </p:cNvSpPr>
          <p:nvPr/>
        </p:nvSpPr>
        <p:spPr bwMode="auto">
          <a:xfrm>
            <a:off x="5194418" y="4310062"/>
            <a:ext cx="57150" cy="71438"/>
          </a:xfrm>
          <a:custGeom>
            <a:avLst/>
            <a:gdLst>
              <a:gd name="T0" fmla="*/ 31 w 73"/>
              <a:gd name="T1" fmla="*/ 90 h 90"/>
              <a:gd name="T2" fmla="*/ 31 w 73"/>
              <a:gd name="T3" fmla="*/ 6 h 90"/>
              <a:gd name="T4" fmla="*/ 42 w 73"/>
              <a:gd name="T5" fmla="*/ 6 h 90"/>
              <a:gd name="T6" fmla="*/ 42 w 73"/>
              <a:gd name="T7" fmla="*/ 90 h 90"/>
              <a:gd name="T8" fmla="*/ 31 w 73"/>
              <a:gd name="T9" fmla="*/ 90 h 90"/>
              <a:gd name="T10" fmla="*/ 0 w 73"/>
              <a:gd name="T11" fmla="*/ 0 h 90"/>
              <a:gd name="T12" fmla="*/ 73 w 73"/>
              <a:gd name="T13" fmla="*/ 0 h 90"/>
              <a:gd name="T14" fmla="*/ 73 w 73"/>
              <a:gd name="T15" fmla="*/ 12 h 90"/>
              <a:gd name="T16" fmla="*/ 0 w 73"/>
              <a:gd name="T17" fmla="*/ 12 h 90"/>
              <a:gd name="T18" fmla="*/ 0 w 73"/>
              <a:gd name="T19" fmla="*/ 0 h 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73" h="90">
                <a:moveTo>
                  <a:pt x="31" y="90"/>
                </a:moveTo>
                <a:lnTo>
                  <a:pt x="31" y="6"/>
                </a:lnTo>
                <a:lnTo>
                  <a:pt x="42" y="6"/>
                </a:lnTo>
                <a:lnTo>
                  <a:pt x="42" y="90"/>
                </a:lnTo>
                <a:lnTo>
                  <a:pt x="31" y="90"/>
                </a:lnTo>
                <a:close/>
                <a:moveTo>
                  <a:pt x="0" y="0"/>
                </a:moveTo>
                <a:lnTo>
                  <a:pt x="73" y="0"/>
                </a:lnTo>
                <a:lnTo>
                  <a:pt x="73" y="12"/>
                </a:lnTo>
                <a:lnTo>
                  <a:pt x="0" y="1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" name="Freeform 13"/>
          <p:cNvSpPr>
            <a:spLocks noEditPoints="1"/>
          </p:cNvSpPr>
          <p:nvPr/>
        </p:nvSpPr>
        <p:spPr bwMode="auto">
          <a:xfrm>
            <a:off x="4414956" y="3667125"/>
            <a:ext cx="57150" cy="257175"/>
          </a:xfrm>
          <a:custGeom>
            <a:avLst/>
            <a:gdLst>
              <a:gd name="T0" fmla="*/ 30 w 73"/>
              <a:gd name="T1" fmla="*/ 317 h 322"/>
              <a:gd name="T2" fmla="*/ 30 w 73"/>
              <a:gd name="T3" fmla="*/ 207 h 322"/>
              <a:gd name="T4" fmla="*/ 30 w 73"/>
              <a:gd name="T5" fmla="*/ 6 h 322"/>
              <a:gd name="T6" fmla="*/ 42 w 73"/>
              <a:gd name="T7" fmla="*/ 6 h 322"/>
              <a:gd name="T8" fmla="*/ 42 w 73"/>
              <a:gd name="T9" fmla="*/ 207 h 322"/>
              <a:gd name="T10" fmla="*/ 42 w 73"/>
              <a:gd name="T11" fmla="*/ 317 h 322"/>
              <a:gd name="T12" fmla="*/ 30 w 73"/>
              <a:gd name="T13" fmla="*/ 317 h 322"/>
              <a:gd name="T14" fmla="*/ 0 w 73"/>
              <a:gd name="T15" fmla="*/ 311 h 322"/>
              <a:gd name="T16" fmla="*/ 73 w 73"/>
              <a:gd name="T17" fmla="*/ 311 h 322"/>
              <a:gd name="T18" fmla="*/ 73 w 73"/>
              <a:gd name="T19" fmla="*/ 322 h 322"/>
              <a:gd name="T20" fmla="*/ 0 w 73"/>
              <a:gd name="T21" fmla="*/ 322 h 322"/>
              <a:gd name="T22" fmla="*/ 0 w 73"/>
              <a:gd name="T23" fmla="*/ 311 h 322"/>
              <a:gd name="T24" fmla="*/ 0 w 73"/>
              <a:gd name="T25" fmla="*/ 0 h 322"/>
              <a:gd name="T26" fmla="*/ 73 w 73"/>
              <a:gd name="T27" fmla="*/ 0 h 322"/>
              <a:gd name="T28" fmla="*/ 73 w 73"/>
              <a:gd name="T29" fmla="*/ 11 h 322"/>
              <a:gd name="T30" fmla="*/ 0 w 73"/>
              <a:gd name="T31" fmla="*/ 11 h 322"/>
              <a:gd name="T32" fmla="*/ 0 w 73"/>
              <a:gd name="T33" fmla="*/ 0 h 3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73" h="322">
                <a:moveTo>
                  <a:pt x="30" y="317"/>
                </a:moveTo>
                <a:lnTo>
                  <a:pt x="30" y="207"/>
                </a:lnTo>
                <a:lnTo>
                  <a:pt x="30" y="6"/>
                </a:lnTo>
                <a:lnTo>
                  <a:pt x="42" y="6"/>
                </a:lnTo>
                <a:lnTo>
                  <a:pt x="42" y="207"/>
                </a:lnTo>
                <a:lnTo>
                  <a:pt x="42" y="317"/>
                </a:lnTo>
                <a:lnTo>
                  <a:pt x="30" y="317"/>
                </a:lnTo>
                <a:close/>
                <a:moveTo>
                  <a:pt x="0" y="311"/>
                </a:moveTo>
                <a:lnTo>
                  <a:pt x="73" y="311"/>
                </a:lnTo>
                <a:lnTo>
                  <a:pt x="73" y="322"/>
                </a:lnTo>
                <a:lnTo>
                  <a:pt x="0" y="322"/>
                </a:lnTo>
                <a:lnTo>
                  <a:pt x="0" y="311"/>
                </a:lnTo>
                <a:close/>
                <a:moveTo>
                  <a:pt x="0" y="0"/>
                </a:moveTo>
                <a:lnTo>
                  <a:pt x="73" y="0"/>
                </a:lnTo>
                <a:lnTo>
                  <a:pt x="73" y="11"/>
                </a:lnTo>
                <a:lnTo>
                  <a:pt x="0" y="11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" name="Freeform 14"/>
          <p:cNvSpPr>
            <a:spLocks noEditPoints="1"/>
          </p:cNvSpPr>
          <p:nvPr/>
        </p:nvSpPr>
        <p:spPr bwMode="auto">
          <a:xfrm>
            <a:off x="5505568" y="4002087"/>
            <a:ext cx="57150" cy="120650"/>
          </a:xfrm>
          <a:custGeom>
            <a:avLst/>
            <a:gdLst>
              <a:gd name="T0" fmla="*/ 30 w 71"/>
              <a:gd name="T1" fmla="*/ 146 h 152"/>
              <a:gd name="T2" fmla="*/ 30 w 71"/>
              <a:gd name="T3" fmla="*/ 39 h 152"/>
              <a:gd name="T4" fmla="*/ 30 w 71"/>
              <a:gd name="T5" fmla="*/ 6 h 152"/>
              <a:gd name="T6" fmla="*/ 42 w 71"/>
              <a:gd name="T7" fmla="*/ 6 h 152"/>
              <a:gd name="T8" fmla="*/ 42 w 71"/>
              <a:gd name="T9" fmla="*/ 39 h 152"/>
              <a:gd name="T10" fmla="*/ 42 w 71"/>
              <a:gd name="T11" fmla="*/ 146 h 152"/>
              <a:gd name="T12" fmla="*/ 30 w 71"/>
              <a:gd name="T13" fmla="*/ 146 h 152"/>
              <a:gd name="T14" fmla="*/ 0 w 71"/>
              <a:gd name="T15" fmla="*/ 140 h 152"/>
              <a:gd name="T16" fmla="*/ 71 w 71"/>
              <a:gd name="T17" fmla="*/ 140 h 152"/>
              <a:gd name="T18" fmla="*/ 71 w 71"/>
              <a:gd name="T19" fmla="*/ 152 h 152"/>
              <a:gd name="T20" fmla="*/ 0 w 71"/>
              <a:gd name="T21" fmla="*/ 152 h 152"/>
              <a:gd name="T22" fmla="*/ 0 w 71"/>
              <a:gd name="T23" fmla="*/ 140 h 152"/>
              <a:gd name="T24" fmla="*/ 0 w 71"/>
              <a:gd name="T25" fmla="*/ 0 h 152"/>
              <a:gd name="T26" fmla="*/ 71 w 71"/>
              <a:gd name="T27" fmla="*/ 0 h 152"/>
              <a:gd name="T28" fmla="*/ 71 w 71"/>
              <a:gd name="T29" fmla="*/ 12 h 152"/>
              <a:gd name="T30" fmla="*/ 0 w 71"/>
              <a:gd name="T31" fmla="*/ 12 h 152"/>
              <a:gd name="T32" fmla="*/ 0 w 71"/>
              <a:gd name="T33" fmla="*/ 0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71" h="152">
                <a:moveTo>
                  <a:pt x="30" y="146"/>
                </a:moveTo>
                <a:lnTo>
                  <a:pt x="30" y="39"/>
                </a:lnTo>
                <a:lnTo>
                  <a:pt x="30" y="6"/>
                </a:lnTo>
                <a:lnTo>
                  <a:pt x="42" y="6"/>
                </a:lnTo>
                <a:lnTo>
                  <a:pt x="42" y="39"/>
                </a:lnTo>
                <a:lnTo>
                  <a:pt x="42" y="146"/>
                </a:lnTo>
                <a:lnTo>
                  <a:pt x="30" y="146"/>
                </a:lnTo>
                <a:close/>
                <a:moveTo>
                  <a:pt x="0" y="140"/>
                </a:moveTo>
                <a:lnTo>
                  <a:pt x="71" y="140"/>
                </a:lnTo>
                <a:lnTo>
                  <a:pt x="71" y="152"/>
                </a:lnTo>
                <a:lnTo>
                  <a:pt x="0" y="152"/>
                </a:lnTo>
                <a:lnTo>
                  <a:pt x="0" y="140"/>
                </a:lnTo>
                <a:close/>
                <a:moveTo>
                  <a:pt x="0" y="0"/>
                </a:moveTo>
                <a:lnTo>
                  <a:pt x="71" y="0"/>
                </a:lnTo>
                <a:lnTo>
                  <a:pt x="71" y="12"/>
                </a:lnTo>
                <a:lnTo>
                  <a:pt x="0" y="1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" name="Rectangle 15"/>
          <p:cNvSpPr>
            <a:spLocks noChangeArrowheads="1"/>
          </p:cNvSpPr>
          <p:nvPr/>
        </p:nvSpPr>
        <p:spPr bwMode="auto">
          <a:xfrm>
            <a:off x="3738681" y="3475037"/>
            <a:ext cx="7938" cy="2157413"/>
          </a:xfrm>
          <a:prstGeom prst="rect">
            <a:avLst/>
          </a:prstGeom>
          <a:solidFill>
            <a:srgbClr val="868686"/>
          </a:solidFill>
          <a:ln w="1588">
            <a:solidFill>
              <a:srgbClr val="868686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" name="Freeform 16"/>
          <p:cNvSpPr>
            <a:spLocks noEditPoints="1"/>
          </p:cNvSpPr>
          <p:nvPr/>
        </p:nvSpPr>
        <p:spPr bwMode="auto">
          <a:xfrm>
            <a:off x="3697406" y="3471862"/>
            <a:ext cx="44450" cy="2165350"/>
          </a:xfrm>
          <a:custGeom>
            <a:avLst/>
            <a:gdLst>
              <a:gd name="T0" fmla="*/ 0 w 58"/>
              <a:gd name="T1" fmla="*/ 2717 h 2728"/>
              <a:gd name="T2" fmla="*/ 58 w 58"/>
              <a:gd name="T3" fmla="*/ 2717 h 2728"/>
              <a:gd name="T4" fmla="*/ 58 w 58"/>
              <a:gd name="T5" fmla="*/ 2728 h 2728"/>
              <a:gd name="T6" fmla="*/ 0 w 58"/>
              <a:gd name="T7" fmla="*/ 2728 h 2728"/>
              <a:gd name="T8" fmla="*/ 0 w 58"/>
              <a:gd name="T9" fmla="*/ 2717 h 2728"/>
              <a:gd name="T10" fmla="*/ 0 w 58"/>
              <a:gd name="T11" fmla="*/ 2174 h 2728"/>
              <a:gd name="T12" fmla="*/ 58 w 58"/>
              <a:gd name="T13" fmla="*/ 2174 h 2728"/>
              <a:gd name="T14" fmla="*/ 58 w 58"/>
              <a:gd name="T15" fmla="*/ 2185 h 2728"/>
              <a:gd name="T16" fmla="*/ 0 w 58"/>
              <a:gd name="T17" fmla="*/ 2185 h 2728"/>
              <a:gd name="T18" fmla="*/ 0 w 58"/>
              <a:gd name="T19" fmla="*/ 2174 h 2728"/>
              <a:gd name="T20" fmla="*/ 0 w 58"/>
              <a:gd name="T21" fmla="*/ 1630 h 2728"/>
              <a:gd name="T22" fmla="*/ 58 w 58"/>
              <a:gd name="T23" fmla="*/ 1630 h 2728"/>
              <a:gd name="T24" fmla="*/ 58 w 58"/>
              <a:gd name="T25" fmla="*/ 1642 h 2728"/>
              <a:gd name="T26" fmla="*/ 0 w 58"/>
              <a:gd name="T27" fmla="*/ 1642 h 2728"/>
              <a:gd name="T28" fmla="*/ 0 w 58"/>
              <a:gd name="T29" fmla="*/ 1630 h 2728"/>
              <a:gd name="T30" fmla="*/ 0 w 58"/>
              <a:gd name="T31" fmla="*/ 1087 h 2728"/>
              <a:gd name="T32" fmla="*/ 58 w 58"/>
              <a:gd name="T33" fmla="*/ 1087 h 2728"/>
              <a:gd name="T34" fmla="*/ 58 w 58"/>
              <a:gd name="T35" fmla="*/ 1098 h 2728"/>
              <a:gd name="T36" fmla="*/ 0 w 58"/>
              <a:gd name="T37" fmla="*/ 1098 h 2728"/>
              <a:gd name="T38" fmla="*/ 0 w 58"/>
              <a:gd name="T39" fmla="*/ 1087 h 2728"/>
              <a:gd name="T40" fmla="*/ 0 w 58"/>
              <a:gd name="T41" fmla="*/ 544 h 2728"/>
              <a:gd name="T42" fmla="*/ 58 w 58"/>
              <a:gd name="T43" fmla="*/ 544 h 2728"/>
              <a:gd name="T44" fmla="*/ 58 w 58"/>
              <a:gd name="T45" fmla="*/ 555 h 2728"/>
              <a:gd name="T46" fmla="*/ 0 w 58"/>
              <a:gd name="T47" fmla="*/ 555 h 2728"/>
              <a:gd name="T48" fmla="*/ 0 w 58"/>
              <a:gd name="T49" fmla="*/ 544 h 2728"/>
              <a:gd name="T50" fmla="*/ 0 w 58"/>
              <a:gd name="T51" fmla="*/ 0 h 2728"/>
              <a:gd name="T52" fmla="*/ 58 w 58"/>
              <a:gd name="T53" fmla="*/ 0 h 2728"/>
              <a:gd name="T54" fmla="*/ 58 w 58"/>
              <a:gd name="T55" fmla="*/ 12 h 2728"/>
              <a:gd name="T56" fmla="*/ 0 w 58"/>
              <a:gd name="T57" fmla="*/ 12 h 2728"/>
              <a:gd name="T58" fmla="*/ 0 w 58"/>
              <a:gd name="T59" fmla="*/ 0 h 27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58" h="2728">
                <a:moveTo>
                  <a:pt x="0" y="2717"/>
                </a:moveTo>
                <a:lnTo>
                  <a:pt x="58" y="2717"/>
                </a:lnTo>
                <a:lnTo>
                  <a:pt x="58" y="2728"/>
                </a:lnTo>
                <a:lnTo>
                  <a:pt x="0" y="2728"/>
                </a:lnTo>
                <a:lnTo>
                  <a:pt x="0" y="2717"/>
                </a:lnTo>
                <a:close/>
                <a:moveTo>
                  <a:pt x="0" y="2174"/>
                </a:moveTo>
                <a:lnTo>
                  <a:pt x="58" y="2174"/>
                </a:lnTo>
                <a:lnTo>
                  <a:pt x="58" y="2185"/>
                </a:lnTo>
                <a:lnTo>
                  <a:pt x="0" y="2185"/>
                </a:lnTo>
                <a:lnTo>
                  <a:pt x="0" y="2174"/>
                </a:lnTo>
                <a:close/>
                <a:moveTo>
                  <a:pt x="0" y="1630"/>
                </a:moveTo>
                <a:lnTo>
                  <a:pt x="58" y="1630"/>
                </a:lnTo>
                <a:lnTo>
                  <a:pt x="58" y="1642"/>
                </a:lnTo>
                <a:lnTo>
                  <a:pt x="0" y="1642"/>
                </a:lnTo>
                <a:lnTo>
                  <a:pt x="0" y="1630"/>
                </a:lnTo>
                <a:close/>
                <a:moveTo>
                  <a:pt x="0" y="1087"/>
                </a:moveTo>
                <a:lnTo>
                  <a:pt x="58" y="1087"/>
                </a:lnTo>
                <a:lnTo>
                  <a:pt x="58" y="1098"/>
                </a:lnTo>
                <a:lnTo>
                  <a:pt x="0" y="1098"/>
                </a:lnTo>
                <a:lnTo>
                  <a:pt x="0" y="1087"/>
                </a:lnTo>
                <a:close/>
                <a:moveTo>
                  <a:pt x="0" y="544"/>
                </a:moveTo>
                <a:lnTo>
                  <a:pt x="58" y="544"/>
                </a:lnTo>
                <a:lnTo>
                  <a:pt x="58" y="555"/>
                </a:lnTo>
                <a:lnTo>
                  <a:pt x="0" y="555"/>
                </a:lnTo>
                <a:lnTo>
                  <a:pt x="0" y="544"/>
                </a:lnTo>
                <a:close/>
                <a:moveTo>
                  <a:pt x="0" y="0"/>
                </a:moveTo>
                <a:lnTo>
                  <a:pt x="58" y="0"/>
                </a:lnTo>
                <a:lnTo>
                  <a:pt x="58" y="12"/>
                </a:lnTo>
                <a:lnTo>
                  <a:pt x="0" y="12"/>
                </a:lnTo>
                <a:lnTo>
                  <a:pt x="0" y="0"/>
                </a:lnTo>
                <a:close/>
              </a:path>
            </a:pathLst>
          </a:custGeom>
          <a:solidFill>
            <a:srgbClr val="868686"/>
          </a:solidFill>
          <a:ln w="1588">
            <a:solidFill>
              <a:srgbClr val="868686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" name="Rectangle 17"/>
          <p:cNvSpPr>
            <a:spLocks noChangeArrowheads="1"/>
          </p:cNvSpPr>
          <p:nvPr/>
        </p:nvSpPr>
        <p:spPr bwMode="auto">
          <a:xfrm>
            <a:off x="3741856" y="5627687"/>
            <a:ext cx="2181225" cy="9525"/>
          </a:xfrm>
          <a:prstGeom prst="rect">
            <a:avLst/>
          </a:prstGeom>
          <a:solidFill>
            <a:srgbClr val="868686"/>
          </a:solidFill>
          <a:ln w="1588">
            <a:solidFill>
              <a:srgbClr val="868686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" name="Freeform 18"/>
          <p:cNvSpPr>
            <a:spLocks noEditPoints="1"/>
          </p:cNvSpPr>
          <p:nvPr/>
        </p:nvSpPr>
        <p:spPr bwMode="auto">
          <a:xfrm>
            <a:off x="3738681" y="5632450"/>
            <a:ext cx="2189163" cy="44450"/>
          </a:xfrm>
          <a:custGeom>
            <a:avLst/>
            <a:gdLst>
              <a:gd name="T0" fmla="*/ 12 w 2760"/>
              <a:gd name="T1" fmla="*/ 0 h 55"/>
              <a:gd name="T2" fmla="*/ 12 w 2760"/>
              <a:gd name="T3" fmla="*/ 55 h 55"/>
              <a:gd name="T4" fmla="*/ 0 w 2760"/>
              <a:gd name="T5" fmla="*/ 55 h 55"/>
              <a:gd name="T6" fmla="*/ 0 w 2760"/>
              <a:gd name="T7" fmla="*/ 0 h 55"/>
              <a:gd name="T8" fmla="*/ 12 w 2760"/>
              <a:gd name="T9" fmla="*/ 0 h 55"/>
              <a:gd name="T10" fmla="*/ 1387 w 2760"/>
              <a:gd name="T11" fmla="*/ 0 h 55"/>
              <a:gd name="T12" fmla="*/ 1387 w 2760"/>
              <a:gd name="T13" fmla="*/ 55 h 55"/>
              <a:gd name="T14" fmla="*/ 1375 w 2760"/>
              <a:gd name="T15" fmla="*/ 55 h 55"/>
              <a:gd name="T16" fmla="*/ 1375 w 2760"/>
              <a:gd name="T17" fmla="*/ 0 h 55"/>
              <a:gd name="T18" fmla="*/ 1387 w 2760"/>
              <a:gd name="T19" fmla="*/ 0 h 55"/>
              <a:gd name="T20" fmla="*/ 2760 w 2760"/>
              <a:gd name="T21" fmla="*/ 0 h 55"/>
              <a:gd name="T22" fmla="*/ 2760 w 2760"/>
              <a:gd name="T23" fmla="*/ 55 h 55"/>
              <a:gd name="T24" fmla="*/ 2748 w 2760"/>
              <a:gd name="T25" fmla="*/ 55 h 55"/>
              <a:gd name="T26" fmla="*/ 2748 w 2760"/>
              <a:gd name="T27" fmla="*/ 0 h 55"/>
              <a:gd name="T28" fmla="*/ 2760 w 2760"/>
              <a:gd name="T29" fmla="*/ 0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2760" h="55">
                <a:moveTo>
                  <a:pt x="12" y="0"/>
                </a:moveTo>
                <a:lnTo>
                  <a:pt x="12" y="55"/>
                </a:lnTo>
                <a:lnTo>
                  <a:pt x="0" y="55"/>
                </a:lnTo>
                <a:lnTo>
                  <a:pt x="0" y="0"/>
                </a:lnTo>
                <a:lnTo>
                  <a:pt x="12" y="0"/>
                </a:lnTo>
                <a:close/>
                <a:moveTo>
                  <a:pt x="1387" y="0"/>
                </a:moveTo>
                <a:lnTo>
                  <a:pt x="1387" y="55"/>
                </a:lnTo>
                <a:lnTo>
                  <a:pt x="1375" y="55"/>
                </a:lnTo>
                <a:lnTo>
                  <a:pt x="1375" y="0"/>
                </a:lnTo>
                <a:lnTo>
                  <a:pt x="1387" y="0"/>
                </a:lnTo>
                <a:close/>
                <a:moveTo>
                  <a:pt x="2760" y="0"/>
                </a:moveTo>
                <a:lnTo>
                  <a:pt x="2760" y="55"/>
                </a:lnTo>
                <a:lnTo>
                  <a:pt x="2748" y="55"/>
                </a:lnTo>
                <a:lnTo>
                  <a:pt x="2748" y="0"/>
                </a:lnTo>
                <a:lnTo>
                  <a:pt x="2760" y="0"/>
                </a:lnTo>
                <a:close/>
              </a:path>
            </a:pathLst>
          </a:custGeom>
          <a:solidFill>
            <a:srgbClr val="868686"/>
          </a:solidFill>
          <a:ln w="1588">
            <a:solidFill>
              <a:srgbClr val="868686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" name="Rectangle 19"/>
          <p:cNvSpPr>
            <a:spLocks noChangeArrowheads="1"/>
          </p:cNvSpPr>
          <p:nvPr/>
        </p:nvSpPr>
        <p:spPr bwMode="auto">
          <a:xfrm>
            <a:off x="3537068" y="5541962"/>
            <a:ext cx="136525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2" name="Rectangle 20"/>
          <p:cNvSpPr>
            <a:spLocks noChangeArrowheads="1"/>
          </p:cNvSpPr>
          <p:nvPr/>
        </p:nvSpPr>
        <p:spPr bwMode="auto">
          <a:xfrm>
            <a:off x="3537068" y="5110162"/>
            <a:ext cx="136525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5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3" name="Rectangle 21"/>
          <p:cNvSpPr>
            <a:spLocks noChangeArrowheads="1"/>
          </p:cNvSpPr>
          <p:nvPr/>
        </p:nvSpPr>
        <p:spPr bwMode="auto">
          <a:xfrm>
            <a:off x="3460868" y="4678362"/>
            <a:ext cx="212725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10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4" name="Rectangle 22"/>
          <p:cNvSpPr>
            <a:spLocks noChangeArrowheads="1"/>
          </p:cNvSpPr>
          <p:nvPr/>
        </p:nvSpPr>
        <p:spPr bwMode="auto">
          <a:xfrm>
            <a:off x="3460868" y="4248150"/>
            <a:ext cx="212725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15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5" name="Rectangle 23"/>
          <p:cNvSpPr>
            <a:spLocks noChangeArrowheads="1"/>
          </p:cNvSpPr>
          <p:nvPr/>
        </p:nvSpPr>
        <p:spPr bwMode="auto">
          <a:xfrm>
            <a:off x="3460868" y="3816350"/>
            <a:ext cx="212725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20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6" name="Rectangle 24"/>
          <p:cNvSpPr>
            <a:spLocks noChangeArrowheads="1"/>
          </p:cNvSpPr>
          <p:nvPr/>
        </p:nvSpPr>
        <p:spPr bwMode="auto">
          <a:xfrm>
            <a:off x="3460868" y="3384550"/>
            <a:ext cx="212725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25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7" name="Rectangle 25"/>
          <p:cNvSpPr>
            <a:spLocks noChangeArrowheads="1"/>
          </p:cNvSpPr>
          <p:nvPr/>
        </p:nvSpPr>
        <p:spPr bwMode="auto">
          <a:xfrm>
            <a:off x="4195881" y="5721350"/>
            <a:ext cx="249238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iCt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8" name="Rectangle 26"/>
          <p:cNvSpPr>
            <a:spLocks noChangeArrowheads="1"/>
          </p:cNvSpPr>
          <p:nvPr/>
        </p:nvSpPr>
        <p:spPr bwMode="auto">
          <a:xfrm>
            <a:off x="5142031" y="5721350"/>
            <a:ext cx="533400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iEpac-1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9" name="Rectangle 27"/>
          <p:cNvSpPr>
            <a:spLocks noChangeArrowheads="1"/>
          </p:cNvSpPr>
          <p:nvPr/>
        </p:nvSpPr>
        <p:spPr bwMode="auto">
          <a:xfrm>
            <a:off x="3429118" y="2554287"/>
            <a:ext cx="2406650" cy="4635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" name="Rectangle 28"/>
          <p:cNvSpPr>
            <a:spLocks noChangeArrowheads="1"/>
          </p:cNvSpPr>
          <p:nvPr/>
        </p:nvSpPr>
        <p:spPr bwMode="auto">
          <a:xfrm>
            <a:off x="3868856" y="2747962"/>
            <a:ext cx="76200" cy="762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" name="Rectangle 29"/>
          <p:cNvSpPr>
            <a:spLocks noChangeArrowheads="1"/>
          </p:cNvSpPr>
          <p:nvPr/>
        </p:nvSpPr>
        <p:spPr bwMode="auto">
          <a:xfrm>
            <a:off x="3978393" y="2695575"/>
            <a:ext cx="43601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p-</a:t>
            </a:r>
            <a:r>
              <a:rPr kumimoji="1" lang="en-US" altLang="ja-JP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ER</a:t>
            </a:r>
            <a:r>
              <a:rPr kumimoji="1" lang="ja-JP" altLang="ja-JP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K</a:t>
            </a:r>
            <a:endParaRPr kumimoji="1" lang="ja-JP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2" name="Rectangle 30"/>
          <p:cNvSpPr>
            <a:spLocks noChangeArrowheads="1"/>
          </p:cNvSpPr>
          <p:nvPr/>
        </p:nvSpPr>
        <p:spPr bwMode="auto">
          <a:xfrm>
            <a:off x="4981693" y="2747962"/>
            <a:ext cx="76200" cy="762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" name="Freeform 31"/>
          <p:cNvSpPr>
            <a:spLocks noEditPoints="1"/>
          </p:cNvSpPr>
          <p:nvPr/>
        </p:nvSpPr>
        <p:spPr bwMode="auto">
          <a:xfrm>
            <a:off x="4976931" y="2743200"/>
            <a:ext cx="85725" cy="84138"/>
          </a:xfrm>
          <a:custGeom>
            <a:avLst/>
            <a:gdLst>
              <a:gd name="T0" fmla="*/ 0 w 108"/>
              <a:gd name="T1" fmla="*/ 6 h 108"/>
              <a:gd name="T2" fmla="*/ 0 w 108"/>
              <a:gd name="T3" fmla="*/ 0 h 108"/>
              <a:gd name="T4" fmla="*/ 6 w 108"/>
              <a:gd name="T5" fmla="*/ 0 h 108"/>
              <a:gd name="T6" fmla="*/ 102 w 108"/>
              <a:gd name="T7" fmla="*/ 0 h 108"/>
              <a:gd name="T8" fmla="*/ 106 w 108"/>
              <a:gd name="T9" fmla="*/ 0 h 108"/>
              <a:gd name="T10" fmla="*/ 108 w 108"/>
              <a:gd name="T11" fmla="*/ 6 h 108"/>
              <a:gd name="T12" fmla="*/ 108 w 108"/>
              <a:gd name="T13" fmla="*/ 102 h 108"/>
              <a:gd name="T14" fmla="*/ 106 w 108"/>
              <a:gd name="T15" fmla="*/ 106 h 108"/>
              <a:gd name="T16" fmla="*/ 102 w 108"/>
              <a:gd name="T17" fmla="*/ 108 h 108"/>
              <a:gd name="T18" fmla="*/ 6 w 108"/>
              <a:gd name="T19" fmla="*/ 108 h 108"/>
              <a:gd name="T20" fmla="*/ 0 w 108"/>
              <a:gd name="T21" fmla="*/ 106 h 108"/>
              <a:gd name="T22" fmla="*/ 0 w 108"/>
              <a:gd name="T23" fmla="*/ 102 h 108"/>
              <a:gd name="T24" fmla="*/ 0 w 108"/>
              <a:gd name="T25" fmla="*/ 6 h 108"/>
              <a:gd name="T26" fmla="*/ 12 w 108"/>
              <a:gd name="T27" fmla="*/ 102 h 108"/>
              <a:gd name="T28" fmla="*/ 6 w 108"/>
              <a:gd name="T29" fmla="*/ 96 h 108"/>
              <a:gd name="T30" fmla="*/ 102 w 108"/>
              <a:gd name="T31" fmla="*/ 96 h 108"/>
              <a:gd name="T32" fmla="*/ 96 w 108"/>
              <a:gd name="T33" fmla="*/ 102 h 108"/>
              <a:gd name="T34" fmla="*/ 96 w 108"/>
              <a:gd name="T35" fmla="*/ 6 h 108"/>
              <a:gd name="T36" fmla="*/ 102 w 108"/>
              <a:gd name="T37" fmla="*/ 12 h 108"/>
              <a:gd name="T38" fmla="*/ 6 w 108"/>
              <a:gd name="T39" fmla="*/ 12 h 108"/>
              <a:gd name="T40" fmla="*/ 12 w 108"/>
              <a:gd name="T41" fmla="*/ 6 h 108"/>
              <a:gd name="T42" fmla="*/ 12 w 108"/>
              <a:gd name="T43" fmla="*/ 102 h 1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108" h="108">
                <a:moveTo>
                  <a:pt x="0" y="6"/>
                </a:moveTo>
                <a:lnTo>
                  <a:pt x="0" y="0"/>
                </a:lnTo>
                <a:lnTo>
                  <a:pt x="6" y="0"/>
                </a:lnTo>
                <a:lnTo>
                  <a:pt x="102" y="0"/>
                </a:lnTo>
                <a:lnTo>
                  <a:pt x="106" y="0"/>
                </a:lnTo>
                <a:lnTo>
                  <a:pt x="108" y="6"/>
                </a:lnTo>
                <a:lnTo>
                  <a:pt x="108" y="102"/>
                </a:lnTo>
                <a:lnTo>
                  <a:pt x="106" y="106"/>
                </a:lnTo>
                <a:lnTo>
                  <a:pt x="102" y="108"/>
                </a:lnTo>
                <a:lnTo>
                  <a:pt x="6" y="108"/>
                </a:lnTo>
                <a:lnTo>
                  <a:pt x="0" y="106"/>
                </a:lnTo>
                <a:lnTo>
                  <a:pt x="0" y="102"/>
                </a:lnTo>
                <a:lnTo>
                  <a:pt x="0" y="6"/>
                </a:lnTo>
                <a:close/>
                <a:moveTo>
                  <a:pt x="12" y="102"/>
                </a:moveTo>
                <a:lnTo>
                  <a:pt x="6" y="96"/>
                </a:lnTo>
                <a:lnTo>
                  <a:pt x="102" y="96"/>
                </a:lnTo>
                <a:lnTo>
                  <a:pt x="96" y="102"/>
                </a:lnTo>
                <a:lnTo>
                  <a:pt x="96" y="6"/>
                </a:lnTo>
                <a:lnTo>
                  <a:pt x="102" y="12"/>
                </a:lnTo>
                <a:lnTo>
                  <a:pt x="6" y="12"/>
                </a:lnTo>
                <a:lnTo>
                  <a:pt x="12" y="6"/>
                </a:lnTo>
                <a:lnTo>
                  <a:pt x="12" y="102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" name="Rectangle 32"/>
          <p:cNvSpPr>
            <a:spLocks noChangeArrowheads="1"/>
          </p:cNvSpPr>
          <p:nvPr/>
        </p:nvSpPr>
        <p:spPr bwMode="auto">
          <a:xfrm>
            <a:off x="5091231" y="2695575"/>
            <a:ext cx="415925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ＭＳ Ｐゴシック" pitchFamily="50" charset="-128"/>
                <a:cs typeface="ＭＳ Ｐゴシック" pitchFamily="50" charset="-128"/>
              </a:rPr>
              <a:t>p-Akt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83931" y="6336708"/>
            <a:ext cx="2482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uplemental</a:t>
            </a:r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.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1990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8</TotalTime>
  <Words>39</Words>
  <Application>Microsoft Office PowerPoint</Application>
  <PresentationFormat>画面に合わせる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Otsuka Pharmaceutical co., ltd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shimoto, Ayako(橋本　綾子)</dc:creator>
  <cp:lastModifiedBy>Hashimoto, Ayako(橋本　綾子)</cp:lastModifiedBy>
  <cp:revision>150</cp:revision>
  <cp:lastPrinted>2015-05-01T08:38:07Z</cp:lastPrinted>
  <dcterms:created xsi:type="dcterms:W3CDTF">2014-07-17T01:24:30Z</dcterms:created>
  <dcterms:modified xsi:type="dcterms:W3CDTF">2015-05-25T06:21:19Z</dcterms:modified>
</cp:coreProperties>
</file>